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6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Table S1. Primer List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F6FEE8A5-9C87-404D-8492-3C853F20A90D}" type="slidenum">
              <a:rPr lang="en-US" altLang="zh-TW" smtClean="0"/>
              <a:pPr>
                <a:defRPr/>
              </a:pPr>
              <a:t>1</a:t>
            </a:fld>
            <a:endParaRPr lang="en-US" altLang="zh-TW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314A88-9D02-42E0-891D-64D960C9DF0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680FD4-73B5-490F-8371-701FA60E7D4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3A7BAD-3541-4785-8DE5-D9954FF721C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D1682C-DB24-4FE6-A349-F8D592B9D5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B0C9B1-95AF-4B32-8F55-4F1179FA10A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BA8EDA-68D9-4822-9552-E74369906933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C6E1F-E25A-4FEB-957C-CF666FB3041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3F2C6-F33B-4503-A434-0A76B0D0B59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A231C3-DCE4-4A07-83C2-40310C49DAB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947F9-F80A-4C34-B422-2B4F9DEDE6F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0D596E-D6BC-48A2-8C5E-EE267ED8272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smtClean="0"/>
              <a:t>Click to edit Master text styles</a:t>
            </a:r>
          </a:p>
          <a:p>
            <a:pPr lvl="1"/>
            <a:r>
              <a:rPr lang="en-US" altLang="zh-TW" smtClean="0"/>
              <a:t>Second level</a:t>
            </a:r>
          </a:p>
          <a:p>
            <a:pPr lvl="2"/>
            <a:r>
              <a:rPr lang="en-US" altLang="zh-TW" smtClean="0"/>
              <a:t>Third level</a:t>
            </a:r>
          </a:p>
          <a:p>
            <a:pPr lvl="3"/>
            <a:r>
              <a:rPr lang="en-US" altLang="zh-TW" smtClean="0"/>
              <a:t>Fourth level</a:t>
            </a:r>
          </a:p>
          <a:p>
            <a:pPr lvl="4"/>
            <a:r>
              <a:rPr lang="en-US" altLang="zh-TW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  <a:ea typeface="新細明體" pitchFamily="18" charset="-120"/>
              </a:defRPr>
            </a:lvl1pPr>
          </a:lstStyle>
          <a:p>
            <a:pPr>
              <a:defRPr/>
            </a:pPr>
            <a:fld id="{2C5B7070-85AC-4AC6-A406-85AA7B734B3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0" y="306888"/>
          <a:ext cx="6858000" cy="6158271"/>
        </p:xfrm>
        <a:graphic>
          <a:graphicData uri="http://schemas.openxmlformats.org/drawingml/2006/table">
            <a:tbl>
              <a:tblPr/>
              <a:tblGrid>
                <a:gridCol w="1238024"/>
                <a:gridCol w="1238024"/>
                <a:gridCol w="1280377"/>
                <a:gridCol w="3101575"/>
              </a:tblGrid>
              <a:tr h="3688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Target transcripts</a:t>
                      </a:r>
                    </a:p>
                  </a:txBody>
                  <a:tcPr marL="5400" marR="5400" marT="540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Amplification</a:t>
                      </a: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rimer</a:t>
                      </a: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rimer Sequence (5' to 3')</a:t>
                      </a: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rowSpan="1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latin typeface="Times New Roman" pitchFamily="18" charset="0"/>
                          <a:cs typeface="Times New Roman" pitchFamily="18" charset="0"/>
                        </a:rPr>
                        <a:t>lfGHRHR</a:t>
                      </a:r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Partial sequence</a:t>
                      </a:r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LFGHRHR-F6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TRARGMTBATCTACACYRTGG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LFGHRHR-F5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AGCRTCTCDRYTGYAGCCCTCY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LFGHRHR-R1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TGGTTSAGGAARCAGTAGAGRA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5'RACE</a:t>
                      </a: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LFGHRHR-R5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TCTGGAAACAGAATGCCATC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LFGHRHR-R6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AGTGACAAATAGCTGAATGTGGA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LFGHRHR-R7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ACAACCGCCACTGCAAGA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88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Anchor Primer (</a:t>
                      </a:r>
                      <a:r>
                        <a:rPr lang="en-US" sz="1100" b="0" i="0" u="none" strike="noStrike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nP</a:t>
                      </a:r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(CUA)4GGCCACGCGTCGACTAGTACGGGIIGGGIIGGGII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3'RACE</a:t>
                      </a: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LFGHRHR-F9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TTTTTGCCAACATCATCCGAAT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LFGHRHR-F7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CACTGTTTGGAACGCACTAC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AUAP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新細明體" pitchFamily="18" charset="-120"/>
                        </a:rPr>
                        <a:t>GGCCACGCGTCGACTAGTAC</a:t>
                      </a:r>
                      <a:endParaRPr lang="en-US" altLang="zh-TW" sz="1100" dirty="0" smtClean="0">
                        <a:ea typeface="新細明體" pitchFamily="18" charset="-12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Full-length sequence</a:t>
                      </a:r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LFGHRHR-FLF1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TGCAGGTCATTCATCCATTT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LFGHRHR-FLR1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CTTCCTTCCTCTGAATGG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Real-Time</a:t>
                      </a: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LFGHRHR-RTF6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TTCCTTCCAGAGTACATCCAC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LFGHRHR-RTR6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AGTAAACGGTACAAGCCCATAGC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</a:t>
                      </a:r>
                      <a:r>
                        <a:rPr lang="en-US" sz="1200" b="1" i="0" u="none" strike="noStrike" baseline="-25000" dirty="0" smtClean="0"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en-US" sz="1200" b="1" i="0" u="none" strike="noStrike" baseline="-25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Partial sequence</a:t>
                      </a:r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RPR-CXT-F1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CTGTTCTCTTTGCCGAT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RPR-CXT-F3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GATGGGGTGCACCTGCT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PRPR-CXT-R2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TGGAGTCTTGATTATCC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5'RACE</a:t>
                      </a: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R5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TGGGTGTGTGCAGCTCACCT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R7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CAGCCAGGCTCCAGCGTGTA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R8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ACGGTTCCAATTTTAAGCATC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88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Anchor Primer (</a:t>
                      </a:r>
                      <a:r>
                        <a:rPr lang="en-US" sz="1100" b="0" i="0" u="none" strike="noStrike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nP</a:t>
                      </a:r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(CUA)4GGCCACGCGTCGACTAGTACGGGIIGGGIIGGGII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3'RACE</a:t>
                      </a: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F1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TTTATCCTGGAAGCAGGT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F4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CAGAAACTGCTCAGAGGACG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F5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GGATGGACCCCTCACTCCCCTCCG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AUAP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新細明體" pitchFamily="18" charset="-120"/>
                        </a:rPr>
                        <a:t>GGCCACGCGTCGACTAGTAC</a:t>
                      </a:r>
                      <a:endParaRPr lang="en-US" altLang="zh-TW" sz="1100" dirty="0" smtClean="0">
                        <a:ea typeface="新細明體" pitchFamily="18" charset="-12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Full-length sequence</a:t>
                      </a:r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FLF1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ATTCTCCAAACAGAACCAGCT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FLR1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TTGCGCTTTGTACCATCCTAA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Real-Time PCR</a:t>
                      </a:r>
                      <a:endParaRPr lang="en-US" sz="1200" b="1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RTF2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AGCAACAACCCATCAACTCTTCATT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71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xGHRHR-RTR2</a:t>
                      </a:r>
                      <a:endParaRPr lang="en-US" sz="11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AGCAGATGAAGGGGTATGATGA</a:t>
                      </a:r>
                    </a:p>
                  </a:txBody>
                  <a:tcPr marL="5400" marR="5400" marT="54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 Box 4"/>
          <p:cNvSpPr txBox="1">
            <a:spLocks noChangeArrowheads="1"/>
          </p:cNvSpPr>
          <p:nvPr/>
        </p:nvSpPr>
        <p:spPr bwMode="auto">
          <a:xfrm>
            <a:off x="-22225" y="-15552"/>
            <a:ext cx="1579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400" b="1" dirty="0">
                <a:ea typeface="新細明體" pitchFamily="18" charset="-120"/>
              </a:rPr>
              <a:t>TABLE S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3</TotalTime>
  <Words>182</Words>
  <Application>Microsoft Macintosh PowerPoint</Application>
  <PresentationFormat>A4 Paper (210x297 mm)</PresentationFormat>
  <Paragraphs>7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3:03:19Z</dcterms:modified>
</cp:coreProperties>
</file>